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8" r:id="rId2"/>
  </p:sldIdLst>
  <p:sldSz cx="9144000" cy="6858000" type="screen4x3"/>
  <p:notesSz cx="9939338" cy="68072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7294" autoAdjust="0"/>
    <p:restoredTop sz="61835" autoAdjust="0"/>
  </p:normalViewPr>
  <p:slideViewPr>
    <p:cSldViewPr snapToGrid="0">
      <p:cViewPr varScale="1">
        <p:scale>
          <a:sx n="50" d="100"/>
          <a:sy n="50" d="100"/>
        </p:scale>
        <p:origin x="2309" y="3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原　悠" userId="5ca70933-9236-41ae-b51f-a8548861fb70" providerId="ADAL" clId="{AB392377-9983-4F31-87E9-ED4B9E9D2215}"/>
    <pc:docChg chg="delSld">
      <pc:chgData name="原　悠" userId="5ca70933-9236-41ae-b51f-a8548861fb70" providerId="ADAL" clId="{AB392377-9983-4F31-87E9-ED4B9E9D2215}" dt="2023-08-06T06:10:10.751" v="1" actId="47"/>
      <pc:docMkLst>
        <pc:docMk/>
      </pc:docMkLst>
      <pc:sldChg chg="del">
        <pc:chgData name="原　悠" userId="5ca70933-9236-41ae-b51f-a8548861fb70" providerId="ADAL" clId="{AB392377-9983-4F31-87E9-ED4B9E9D2215}" dt="2023-08-06T06:10:08.696" v="0" actId="47"/>
        <pc:sldMkLst>
          <pc:docMk/>
          <pc:sldMk cId="591882563" sldId="256"/>
        </pc:sldMkLst>
      </pc:sldChg>
      <pc:sldChg chg="del">
        <pc:chgData name="原　悠" userId="5ca70933-9236-41ae-b51f-a8548861fb70" providerId="ADAL" clId="{AB392377-9983-4F31-87E9-ED4B9E9D2215}" dt="2023-08-06T06:10:08.696" v="0" actId="47"/>
        <pc:sldMkLst>
          <pc:docMk/>
          <pc:sldMk cId="3505921917" sldId="257"/>
        </pc:sldMkLst>
      </pc:sldChg>
      <pc:sldChg chg="del">
        <pc:chgData name="原　悠" userId="5ca70933-9236-41ae-b51f-a8548861fb70" providerId="ADAL" clId="{AB392377-9983-4F31-87E9-ED4B9E9D2215}" dt="2023-08-06T06:10:10.751" v="1" actId="47"/>
        <pc:sldMkLst>
          <pc:docMk/>
          <pc:sldMk cId="3752763700" sldId="258"/>
        </pc:sldMkLst>
      </pc:sldChg>
      <pc:sldChg chg="del">
        <pc:chgData name="原　悠" userId="5ca70933-9236-41ae-b51f-a8548861fb70" providerId="ADAL" clId="{AB392377-9983-4F31-87E9-ED4B9E9D2215}" dt="2023-08-06T06:10:08.696" v="0" actId="47"/>
        <pc:sldMkLst>
          <pc:docMk/>
          <pc:sldMk cId="2023262087" sldId="259"/>
        </pc:sldMkLst>
      </pc:sldChg>
      <pc:sldChg chg="del">
        <pc:chgData name="原　悠" userId="5ca70933-9236-41ae-b51f-a8548861fb70" providerId="ADAL" clId="{AB392377-9983-4F31-87E9-ED4B9E9D2215}" dt="2023-08-06T06:10:08.696" v="0" actId="47"/>
        <pc:sldMkLst>
          <pc:docMk/>
          <pc:sldMk cId="2163035067" sldId="260"/>
        </pc:sldMkLst>
      </pc:sldChg>
      <pc:sldChg chg="del">
        <pc:chgData name="原　悠" userId="5ca70933-9236-41ae-b51f-a8548861fb70" providerId="ADAL" clId="{AB392377-9983-4F31-87E9-ED4B9E9D2215}" dt="2023-08-06T06:10:08.696" v="0" actId="47"/>
        <pc:sldMkLst>
          <pc:docMk/>
          <pc:sldMk cId="1157327301" sldId="262"/>
        </pc:sldMkLst>
      </pc:sldChg>
      <pc:sldChg chg="del">
        <pc:chgData name="原　悠" userId="5ca70933-9236-41ae-b51f-a8548861fb70" providerId="ADAL" clId="{AB392377-9983-4F31-87E9-ED4B9E9D2215}" dt="2023-08-06T06:10:10.751" v="1" actId="47"/>
        <pc:sldMkLst>
          <pc:docMk/>
          <pc:sldMk cId="3647937715" sldId="274"/>
        </pc:sldMkLst>
      </pc:sldChg>
      <pc:sldChg chg="del">
        <pc:chgData name="原　悠" userId="5ca70933-9236-41ae-b51f-a8548861fb70" providerId="ADAL" clId="{AB392377-9983-4F31-87E9-ED4B9E9D2215}" dt="2023-08-06T06:10:08.696" v="0" actId="47"/>
        <pc:sldMkLst>
          <pc:docMk/>
          <pc:sldMk cId="3904947510" sldId="275"/>
        </pc:sldMkLst>
      </pc:sldChg>
      <pc:sldChg chg="del">
        <pc:chgData name="原　悠" userId="5ca70933-9236-41ae-b51f-a8548861fb70" providerId="ADAL" clId="{AB392377-9983-4F31-87E9-ED4B9E9D2215}" dt="2023-08-06T06:10:08.696" v="0" actId="47"/>
        <pc:sldMkLst>
          <pc:docMk/>
          <pc:sldMk cId="1982311355" sldId="276"/>
        </pc:sldMkLst>
      </pc:sldChg>
      <pc:sldChg chg="del">
        <pc:chgData name="原　悠" userId="5ca70933-9236-41ae-b51f-a8548861fb70" providerId="ADAL" clId="{AB392377-9983-4F31-87E9-ED4B9E9D2215}" dt="2023-08-06T06:10:08.696" v="0" actId="47"/>
        <pc:sldMkLst>
          <pc:docMk/>
          <pc:sldMk cId="1905507674" sldId="277"/>
        </pc:sldMkLst>
      </pc:sldChg>
      <pc:sldChg chg="del">
        <pc:chgData name="原　悠" userId="5ca70933-9236-41ae-b51f-a8548861fb70" providerId="ADAL" clId="{AB392377-9983-4F31-87E9-ED4B9E9D2215}" dt="2023-08-06T06:10:10.751" v="1" actId="47"/>
        <pc:sldMkLst>
          <pc:docMk/>
          <pc:sldMk cId="645788852" sldId="279"/>
        </pc:sldMkLst>
      </pc:sldChg>
    </pc:docChg>
  </pc:docChgLst>
  <pc:docChgLst>
    <pc:chgData name="原　悠" userId="5ca70933-9236-41ae-b51f-a8548861fb70" providerId="ADAL" clId="{AF46780B-1511-4A3E-A647-F33B33846E2B}"/>
    <pc:docChg chg="modSld sldOrd">
      <pc:chgData name="原　悠" userId="5ca70933-9236-41ae-b51f-a8548861fb70" providerId="ADAL" clId="{AF46780B-1511-4A3E-A647-F33B33846E2B}" dt="2023-08-06T04:55:57.273" v="246" actId="13926"/>
      <pc:docMkLst>
        <pc:docMk/>
      </pc:docMkLst>
      <pc:sldChg chg="modSp mod modNotesTx">
        <pc:chgData name="原　悠" userId="5ca70933-9236-41ae-b51f-a8548861fb70" providerId="ADAL" clId="{AF46780B-1511-4A3E-A647-F33B33846E2B}" dt="2023-08-06T03:30:23.266" v="213" actId="13926"/>
        <pc:sldMkLst>
          <pc:docMk/>
          <pc:sldMk cId="3752763700" sldId="258"/>
        </pc:sldMkLst>
        <pc:spChg chg="mod">
          <ac:chgData name="原　悠" userId="5ca70933-9236-41ae-b51f-a8548861fb70" providerId="ADAL" clId="{AF46780B-1511-4A3E-A647-F33B33846E2B}" dt="2023-08-06T03:30:23.266" v="213" actId="13926"/>
          <ac:spMkLst>
            <pc:docMk/>
            <pc:sldMk cId="3752763700" sldId="258"/>
            <ac:spMk id="9" creationId="{67B277C3-A2B8-C76D-EF95-392E1C682D32}"/>
          </ac:spMkLst>
        </pc:spChg>
      </pc:sldChg>
      <pc:sldChg chg="modSp mod modNotesTx">
        <pc:chgData name="原　悠" userId="5ca70933-9236-41ae-b51f-a8548861fb70" providerId="ADAL" clId="{AF46780B-1511-4A3E-A647-F33B33846E2B}" dt="2023-08-06T04:55:57.273" v="246" actId="13926"/>
        <pc:sldMkLst>
          <pc:docMk/>
          <pc:sldMk cId="2023262087" sldId="259"/>
        </pc:sldMkLst>
        <pc:spChg chg="mod">
          <ac:chgData name="原　悠" userId="5ca70933-9236-41ae-b51f-a8548861fb70" providerId="ADAL" clId="{AF46780B-1511-4A3E-A647-F33B33846E2B}" dt="2023-08-06T03:22:34.216" v="188" actId="554"/>
          <ac:spMkLst>
            <pc:docMk/>
            <pc:sldMk cId="2023262087" sldId="259"/>
            <ac:spMk id="3" creationId="{DA3FD359-D048-C3A4-351F-39DEFDA7C99D}"/>
          </ac:spMkLst>
        </pc:spChg>
        <pc:graphicFrameChg chg="mod modGraphic">
          <ac:chgData name="原　悠" userId="5ca70933-9236-41ae-b51f-a8548861fb70" providerId="ADAL" clId="{AF46780B-1511-4A3E-A647-F33B33846E2B}" dt="2023-08-06T03:22:46.536" v="202" actId="555"/>
          <ac:graphicFrameMkLst>
            <pc:docMk/>
            <pc:sldMk cId="2023262087" sldId="259"/>
            <ac:graphicFrameMk id="2" creationId="{091E4CBE-773D-4CA0-B1AF-D12C41AC2F0D}"/>
          </ac:graphicFrameMkLst>
        </pc:graphicFrameChg>
      </pc:sldChg>
      <pc:sldChg chg="modSp mod">
        <pc:chgData name="原　悠" userId="5ca70933-9236-41ae-b51f-a8548861fb70" providerId="ADAL" clId="{AF46780B-1511-4A3E-A647-F33B33846E2B}" dt="2023-08-06T03:28:55.256" v="203" actId="13926"/>
        <pc:sldMkLst>
          <pc:docMk/>
          <pc:sldMk cId="1157327301" sldId="262"/>
        </pc:sldMkLst>
        <pc:graphicFrameChg chg="modGraphic">
          <ac:chgData name="原　悠" userId="5ca70933-9236-41ae-b51f-a8548861fb70" providerId="ADAL" clId="{AF46780B-1511-4A3E-A647-F33B33846E2B}" dt="2023-08-06T03:28:55.256" v="203" actId="13926"/>
          <ac:graphicFrameMkLst>
            <pc:docMk/>
            <pc:sldMk cId="1157327301" sldId="262"/>
            <ac:graphicFrameMk id="5" creationId="{48E08C8B-2E64-DBD8-8590-9662866AFEBD}"/>
          </ac:graphicFrameMkLst>
        </pc:graphicFrameChg>
      </pc:sldChg>
      <pc:sldChg chg="modSp mod ord modNotesTx">
        <pc:chgData name="原　悠" userId="5ca70933-9236-41ae-b51f-a8548861fb70" providerId="ADAL" clId="{AF46780B-1511-4A3E-A647-F33B33846E2B}" dt="2023-08-06T00:48:02.483" v="17" actId="20577"/>
        <pc:sldMkLst>
          <pc:docMk/>
          <pc:sldMk cId="3647937715" sldId="274"/>
        </pc:sldMkLst>
        <pc:spChg chg="mod">
          <ac:chgData name="原　悠" userId="5ca70933-9236-41ae-b51f-a8548861fb70" providerId="ADAL" clId="{AF46780B-1511-4A3E-A647-F33B33846E2B}" dt="2023-08-06T00:47:35.389" v="5" actId="20577"/>
          <ac:spMkLst>
            <pc:docMk/>
            <pc:sldMk cId="3647937715" sldId="274"/>
            <ac:spMk id="5" creationId="{729D6172-477D-C897-A41F-8A8646FC811C}"/>
          </ac:spMkLst>
        </pc:spChg>
      </pc:sldChg>
      <pc:sldChg chg="modSp mod">
        <pc:chgData name="原　悠" userId="5ca70933-9236-41ae-b51f-a8548861fb70" providerId="ADAL" clId="{AF46780B-1511-4A3E-A647-F33B33846E2B}" dt="2023-08-06T03:29:59.785" v="210" actId="12789"/>
        <pc:sldMkLst>
          <pc:docMk/>
          <pc:sldMk cId="1982311355" sldId="276"/>
        </pc:sldMkLst>
        <pc:graphicFrameChg chg="mod modGraphic">
          <ac:chgData name="原　悠" userId="5ca70933-9236-41ae-b51f-a8548861fb70" providerId="ADAL" clId="{AF46780B-1511-4A3E-A647-F33B33846E2B}" dt="2023-08-06T03:29:59.785" v="210" actId="12789"/>
          <ac:graphicFrameMkLst>
            <pc:docMk/>
            <pc:sldMk cId="1982311355" sldId="276"/>
            <ac:graphicFrameMk id="2" creationId="{091E4CBE-773D-4CA0-B1AF-D12C41AC2F0D}"/>
          </ac:graphicFrameMkLst>
        </pc:graphicFrameChg>
      </pc:sldChg>
      <pc:sldChg chg="modSp mod">
        <pc:chgData name="原　悠" userId="5ca70933-9236-41ae-b51f-a8548861fb70" providerId="ADAL" clId="{AF46780B-1511-4A3E-A647-F33B33846E2B}" dt="2023-08-06T03:30:35.692" v="214" actId="13926"/>
        <pc:sldMkLst>
          <pc:docMk/>
          <pc:sldMk cId="1905507674" sldId="277"/>
        </pc:sldMkLst>
        <pc:spChg chg="mod">
          <ac:chgData name="原　悠" userId="5ca70933-9236-41ae-b51f-a8548861fb70" providerId="ADAL" clId="{AF46780B-1511-4A3E-A647-F33B33846E2B}" dt="2023-08-06T03:30:35.692" v="214" actId="13926"/>
          <ac:spMkLst>
            <pc:docMk/>
            <pc:sldMk cId="1905507674" sldId="277"/>
            <ac:spMk id="9" creationId="{A9CA93BC-632A-BA83-6BC2-458BC6CEB551}"/>
          </ac:spMkLst>
        </pc:spChg>
      </pc:sldChg>
      <pc:sldChg chg="modSp mod">
        <pc:chgData name="原　悠" userId="5ca70933-9236-41ae-b51f-a8548861fb70" providerId="ADAL" clId="{AF46780B-1511-4A3E-A647-F33B33846E2B}" dt="2023-08-06T03:30:12.025" v="212" actId="13926"/>
        <pc:sldMkLst>
          <pc:docMk/>
          <pc:sldMk cId="3405513179" sldId="278"/>
        </pc:sldMkLst>
        <pc:spChg chg="mod">
          <ac:chgData name="原　悠" userId="5ca70933-9236-41ae-b51f-a8548861fb70" providerId="ADAL" clId="{AF46780B-1511-4A3E-A647-F33B33846E2B}" dt="2023-08-06T03:30:09.407" v="211" actId="13926"/>
          <ac:spMkLst>
            <pc:docMk/>
            <pc:sldMk cId="3405513179" sldId="278"/>
            <ac:spMk id="3" creationId="{DA3FD359-D048-C3A4-351F-39DEFDA7C99D}"/>
          </ac:spMkLst>
        </pc:spChg>
        <pc:graphicFrameChg chg="modGraphic">
          <ac:chgData name="原　悠" userId="5ca70933-9236-41ae-b51f-a8548861fb70" providerId="ADAL" clId="{AF46780B-1511-4A3E-A647-F33B33846E2B}" dt="2023-08-06T03:30:12.025" v="212" actId="13926"/>
          <ac:graphicFrameMkLst>
            <pc:docMk/>
            <pc:sldMk cId="3405513179" sldId="278"/>
            <ac:graphicFrameMk id="2" creationId="{091E4CBE-773D-4CA0-B1AF-D12C41AC2F0D}"/>
          </ac:graphicFrameMkLst>
        </pc:graphicFrameChg>
      </pc:sldChg>
      <pc:sldChg chg="modSp mod modNotesTx">
        <pc:chgData name="原　悠" userId="5ca70933-9236-41ae-b51f-a8548861fb70" providerId="ADAL" clId="{AF46780B-1511-4A3E-A647-F33B33846E2B}" dt="2023-08-06T00:48:17.270" v="36" actId="20577"/>
        <pc:sldMkLst>
          <pc:docMk/>
          <pc:sldMk cId="645788852" sldId="279"/>
        </pc:sldMkLst>
        <pc:spChg chg="mod">
          <ac:chgData name="原　悠" userId="5ca70933-9236-41ae-b51f-a8548861fb70" providerId="ADAL" clId="{AF46780B-1511-4A3E-A647-F33B33846E2B}" dt="2023-08-06T00:47:50.436" v="13" actId="20577"/>
          <ac:spMkLst>
            <pc:docMk/>
            <pc:sldMk cId="645788852" sldId="279"/>
            <ac:spMk id="2" creationId="{3B9278E9-7B39-A149-F398-838D5393A870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4307046" cy="34154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629992" y="1"/>
            <a:ext cx="4307046" cy="34154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7B7F58F-AC56-4FBF-8A41-91BAC14593A1}" type="datetimeFigureOut">
              <a:rPr kumimoji="1" lang="ja-JP" altLang="en-US" smtClean="0"/>
              <a:t>2023/8/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3438525" y="850900"/>
            <a:ext cx="3062288" cy="22971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93934" y="3275965"/>
            <a:ext cx="7951470" cy="268033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6465659"/>
            <a:ext cx="4307046" cy="34154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629992" y="6465659"/>
            <a:ext cx="4307046" cy="34154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3FFC4C6-D503-4663-8862-A279B0AE57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23654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b="1" dirty="0"/>
              <a:t>Supplement Table 1. </a:t>
            </a:r>
            <a:r>
              <a:rPr kumimoji="1" lang="en-US" altLang="ja-JP" b="0" dirty="0"/>
              <a:t>Patients’ baseline data for </a:t>
            </a:r>
            <a:r>
              <a:rPr kumimoji="1" lang="en-US" altLang="ja-JP" b="0" dirty="0" err="1"/>
              <a:t>nintedanib</a:t>
            </a:r>
            <a:r>
              <a:rPr kumimoji="1" lang="en-US" altLang="ja-JP" b="0" dirty="0"/>
              <a:t> or pirfenidone groups</a:t>
            </a:r>
          </a:p>
          <a:p>
            <a:r>
              <a:rPr kumimoji="1" lang="en-US" altLang="ja-JP" b="1" dirty="0"/>
              <a:t>Footnote: </a:t>
            </a:r>
            <a:r>
              <a:rPr kumimoji="1" lang="en-US" altLang="ja-JP" dirty="0"/>
              <a:t>Data are presented as the median (25</a:t>
            </a:r>
            <a:r>
              <a:rPr kumimoji="1" lang="en-US" altLang="ja-JP" baseline="30000" dirty="0"/>
              <a:t>th</a:t>
            </a:r>
            <a:r>
              <a:rPr kumimoji="1" lang="en-US" altLang="ja-JP" dirty="0"/>
              <a:t>–75</a:t>
            </a:r>
            <a:r>
              <a:rPr kumimoji="1" lang="en-US" altLang="ja-JP" baseline="30000" dirty="0"/>
              <a:t>th</a:t>
            </a:r>
            <a:r>
              <a:rPr kumimoji="1" lang="en-US" altLang="ja-JP" dirty="0"/>
              <a:t> percentiles) or the number (%). </a:t>
            </a:r>
          </a:p>
          <a:p>
            <a:r>
              <a:rPr kumimoji="1" lang="en-US" altLang="ja-JP" b="1" dirty="0"/>
              <a:t>Abbreviations: </a:t>
            </a:r>
            <a:r>
              <a:rPr kumimoji="1" lang="en-US" altLang="ja-JP" b="0" dirty="0"/>
              <a:t>AFT, anti-fibrotic treatment; </a:t>
            </a:r>
            <a:r>
              <a:rPr kumimoji="1" lang="en-US" altLang="ja-JP" dirty="0"/>
              <a:t>CCIS, </a:t>
            </a:r>
            <a:r>
              <a:rPr kumimoji="1" lang="en-US" altLang="ja-JP" dirty="0" err="1"/>
              <a:t>Charlson</a:t>
            </a:r>
            <a:r>
              <a:rPr kumimoji="1" lang="en-US" altLang="ja-JP" dirty="0"/>
              <a:t> Comorbidity Index Score; GAP, gender / age / physiology; HRCT, high resolution computed tomography; %</a:t>
            </a:r>
            <a:r>
              <a:rPr kumimoji="1" lang="en-US" altLang="ja-JP" dirty="0" err="1"/>
              <a:t>DLco</a:t>
            </a:r>
            <a:r>
              <a:rPr kumimoji="1" lang="en-US" altLang="ja-JP" dirty="0"/>
              <a:t>, percentage predicted diffusion capacity of lung for carbon monoxide, %FVC, percentage predicted forced vital capacity; UIP, usual interstitial pneumonia.</a:t>
            </a:r>
          </a:p>
          <a:p>
            <a:endParaRPr kumimoji="1" lang="en-US" altLang="ja-JP" dirty="0"/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AF67088-4D4C-4FF9-8A62-DB23CEB3D6D3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79762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55805-7B7D-441B-9DD8-D76EA3F1F94A}" type="datetimeFigureOut">
              <a:rPr kumimoji="1" lang="ja-JP" altLang="en-US" smtClean="0"/>
              <a:t>2023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92675-4DDD-4055-9C6A-BCB46EE4A5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53754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55805-7B7D-441B-9DD8-D76EA3F1F94A}" type="datetimeFigureOut">
              <a:rPr kumimoji="1" lang="ja-JP" altLang="en-US" smtClean="0"/>
              <a:t>2023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92675-4DDD-4055-9C6A-BCB46EE4A5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72152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55805-7B7D-441B-9DD8-D76EA3F1F94A}" type="datetimeFigureOut">
              <a:rPr kumimoji="1" lang="ja-JP" altLang="en-US" smtClean="0"/>
              <a:t>2023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92675-4DDD-4055-9C6A-BCB46EE4A5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20923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55805-7B7D-441B-9DD8-D76EA3F1F94A}" type="datetimeFigureOut">
              <a:rPr kumimoji="1" lang="ja-JP" altLang="en-US" smtClean="0"/>
              <a:t>2023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92675-4DDD-4055-9C6A-BCB46EE4A5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07436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55805-7B7D-441B-9DD8-D76EA3F1F94A}" type="datetimeFigureOut">
              <a:rPr kumimoji="1" lang="ja-JP" altLang="en-US" smtClean="0"/>
              <a:t>2023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92675-4DDD-4055-9C6A-BCB46EE4A5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06675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55805-7B7D-441B-9DD8-D76EA3F1F94A}" type="datetimeFigureOut">
              <a:rPr kumimoji="1" lang="ja-JP" altLang="en-US" smtClean="0"/>
              <a:t>2023/8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92675-4DDD-4055-9C6A-BCB46EE4A5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01008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55805-7B7D-441B-9DD8-D76EA3F1F94A}" type="datetimeFigureOut">
              <a:rPr kumimoji="1" lang="ja-JP" altLang="en-US" smtClean="0"/>
              <a:t>2023/8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92675-4DDD-4055-9C6A-BCB46EE4A5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37779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55805-7B7D-441B-9DD8-D76EA3F1F94A}" type="datetimeFigureOut">
              <a:rPr kumimoji="1" lang="ja-JP" altLang="en-US" smtClean="0"/>
              <a:t>2023/8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92675-4DDD-4055-9C6A-BCB46EE4A5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75160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55805-7B7D-441B-9DD8-D76EA3F1F94A}" type="datetimeFigureOut">
              <a:rPr kumimoji="1" lang="ja-JP" altLang="en-US" smtClean="0"/>
              <a:t>2023/8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92675-4DDD-4055-9C6A-BCB46EE4A5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52331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55805-7B7D-441B-9DD8-D76EA3F1F94A}" type="datetimeFigureOut">
              <a:rPr kumimoji="1" lang="ja-JP" altLang="en-US" smtClean="0"/>
              <a:t>2023/8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92675-4DDD-4055-9C6A-BCB46EE4A5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17622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D55805-7B7D-441B-9DD8-D76EA3F1F94A}" type="datetimeFigureOut">
              <a:rPr kumimoji="1" lang="ja-JP" altLang="en-US" smtClean="0"/>
              <a:t>2023/8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92675-4DDD-4055-9C6A-BCB46EE4A5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21000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D55805-7B7D-441B-9DD8-D76EA3F1F94A}" type="datetimeFigureOut">
              <a:rPr kumimoji="1" lang="ja-JP" altLang="en-US" smtClean="0"/>
              <a:t>2023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F92675-4DDD-4055-9C6A-BCB46EE4A5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48561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2">
            <a:extLst>
              <a:ext uri="{FF2B5EF4-FFF2-40B4-BE49-F238E27FC236}">
                <a16:creationId xmlns:a16="http://schemas.microsoft.com/office/drawing/2014/main" id="{091E4CBE-773D-4CA0-B1AF-D12C41AC2F0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29911652"/>
              </p:ext>
            </p:extLst>
          </p:nvPr>
        </p:nvGraphicFramePr>
        <p:xfrm>
          <a:off x="0" y="1917839"/>
          <a:ext cx="9144000" cy="3266161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545677">
                  <a:extLst>
                    <a:ext uri="{9D8B030D-6E8A-4147-A177-3AD203B41FA5}">
                      <a16:colId xmlns:a16="http://schemas.microsoft.com/office/drawing/2014/main" val="2110427594"/>
                    </a:ext>
                  </a:extLst>
                </a:gridCol>
                <a:gridCol w="2199441">
                  <a:extLst>
                    <a:ext uri="{9D8B030D-6E8A-4147-A177-3AD203B41FA5}">
                      <a16:colId xmlns:a16="http://schemas.microsoft.com/office/drawing/2014/main" val="4046613032"/>
                    </a:ext>
                  </a:extLst>
                </a:gridCol>
                <a:gridCol w="2199441">
                  <a:extLst>
                    <a:ext uri="{9D8B030D-6E8A-4147-A177-3AD203B41FA5}">
                      <a16:colId xmlns:a16="http://schemas.microsoft.com/office/drawing/2014/main" val="158957339"/>
                    </a:ext>
                  </a:extLst>
                </a:gridCol>
                <a:gridCol w="2199441">
                  <a:extLst>
                    <a:ext uri="{9D8B030D-6E8A-4147-A177-3AD203B41FA5}">
                      <a16:colId xmlns:a16="http://schemas.microsoft.com/office/drawing/2014/main" val="2171471270"/>
                    </a:ext>
                  </a:extLst>
                </a:gridCol>
              </a:tblGrid>
              <a:tr h="340081">
                <a:tc>
                  <a:txBody>
                    <a:bodyPr/>
                    <a:lstStyle/>
                    <a:p>
                      <a:r>
                        <a:rPr kumimoji="1" lang="en-US" altLang="ja-JP" sz="1000" b="1" dirty="0"/>
                        <a:t>Variable</a:t>
                      </a:r>
                      <a:endParaRPr kumimoji="1" lang="ja-JP" altLang="en-US" sz="1000" b="1" dirty="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1" dirty="0" err="1"/>
                        <a:t>Nintedanib</a:t>
                      </a:r>
                      <a:r>
                        <a:rPr kumimoji="1" lang="en-US" altLang="ja-JP" sz="1000" b="1" dirty="0"/>
                        <a:t> (N = 70)</a:t>
                      </a:r>
                      <a:endParaRPr kumimoji="1" lang="ja-JP" altLang="en-US" sz="1000" b="1" dirty="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1" dirty="0" err="1"/>
                        <a:t>Piffenidone</a:t>
                      </a:r>
                      <a:r>
                        <a:rPr kumimoji="1" lang="en-US" altLang="ja-JP" sz="1000" b="1" dirty="0"/>
                        <a:t> (N = 60) </a:t>
                      </a:r>
                      <a:endParaRPr kumimoji="1" lang="ja-JP" altLang="en-US" sz="1000" b="1" dirty="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1" dirty="0"/>
                        <a:t>P value (</a:t>
                      </a:r>
                      <a:r>
                        <a:rPr kumimoji="1" lang="en-US" altLang="ja-JP" sz="1000" b="1" dirty="0" err="1"/>
                        <a:t>nintedanib</a:t>
                      </a:r>
                      <a:r>
                        <a:rPr kumimoji="1" lang="en-US" altLang="ja-JP" sz="1000" b="1" dirty="0"/>
                        <a:t> vs. pirfenidone)</a:t>
                      </a:r>
                      <a:endParaRPr kumimoji="1" lang="ja-JP" altLang="en-US" sz="1000" b="1" dirty="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19590307"/>
                  </a:ext>
                </a:extLst>
              </a:tr>
              <a:tr h="217899">
                <a:tc>
                  <a:txBody>
                    <a:bodyPr/>
                    <a:lstStyle/>
                    <a:p>
                      <a:r>
                        <a:rPr kumimoji="1" lang="en-US" altLang="ja-JP" sz="1000" b="1" dirty="0"/>
                        <a:t>Age</a:t>
                      </a:r>
                      <a:endParaRPr kumimoji="1" lang="ja-JP" altLang="en-US" sz="1000" b="1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/>
                        <a:t>74 (69–77)</a:t>
                      </a:r>
                      <a:endParaRPr kumimoji="1" lang="ja-JP" altLang="en-US" sz="1000" dirty="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/>
                        <a:t>73 (68–77)</a:t>
                      </a:r>
                      <a:endParaRPr kumimoji="1" lang="ja-JP" altLang="en-US" sz="1000" dirty="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/>
                        <a:t>0.44</a:t>
                      </a:r>
                      <a:endParaRPr kumimoji="1" lang="ja-JP" altLang="en-US" sz="1000" dirty="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4055199420"/>
                  </a:ext>
                </a:extLst>
              </a:tr>
              <a:tr h="217899">
                <a:tc>
                  <a:txBody>
                    <a:bodyPr/>
                    <a:lstStyle/>
                    <a:p>
                      <a:r>
                        <a:rPr kumimoji="1" lang="en-US" altLang="ja-JP" sz="1000" b="1" dirty="0"/>
                        <a:t>Male, N (%)</a:t>
                      </a:r>
                      <a:endParaRPr kumimoji="1" lang="ja-JP" altLang="en-US" sz="10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/>
                        <a:t>55 (79)</a:t>
                      </a:r>
                      <a:endParaRPr kumimoji="1" lang="ja-JP" altLang="en-US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/>
                        <a:t>46 (77)</a:t>
                      </a:r>
                      <a:endParaRPr kumimoji="1" lang="ja-JP" altLang="en-US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/>
                        <a:t>0.78</a:t>
                      </a:r>
                      <a:endParaRPr kumimoji="1" lang="ja-JP" altLang="en-US" sz="10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888492087"/>
                  </a:ext>
                </a:extLst>
              </a:tr>
              <a:tr h="217899">
                <a:tc>
                  <a:txBody>
                    <a:bodyPr/>
                    <a:lstStyle/>
                    <a:p>
                      <a:r>
                        <a:rPr kumimoji="1" lang="en-US" altLang="ja-JP" sz="1000" b="1" dirty="0"/>
                        <a:t>Never smoker, N (%)</a:t>
                      </a:r>
                      <a:endParaRPr kumimoji="1" lang="ja-JP" altLang="en-US" sz="10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/>
                        <a:t>20 (29)</a:t>
                      </a:r>
                      <a:endParaRPr kumimoji="1" lang="ja-JP" altLang="en-US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/>
                        <a:t>15 (25)</a:t>
                      </a:r>
                      <a:endParaRPr kumimoji="1" lang="ja-JP" altLang="en-US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/>
                        <a:t>0.69</a:t>
                      </a:r>
                      <a:endParaRPr kumimoji="1" lang="ja-JP" altLang="en-US" sz="10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30678071"/>
                  </a:ext>
                </a:extLst>
              </a:tr>
              <a:tr h="217899">
                <a:tc>
                  <a:txBody>
                    <a:bodyPr/>
                    <a:lstStyle/>
                    <a:p>
                      <a:r>
                        <a:rPr kumimoji="1" lang="en-US" altLang="ja-JP" sz="1000" b="1" dirty="0"/>
                        <a:t>CCIS</a:t>
                      </a:r>
                      <a:endParaRPr kumimoji="1" lang="ja-JP" altLang="en-US" sz="10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/>
                        <a:t>2 (1–3)</a:t>
                      </a:r>
                      <a:endParaRPr kumimoji="1" lang="ja-JP" altLang="en-US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/>
                        <a:t>2 (1–3)</a:t>
                      </a:r>
                      <a:endParaRPr kumimoji="1" lang="ja-JP" altLang="en-US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/>
                        <a:t>0.54</a:t>
                      </a:r>
                      <a:endParaRPr kumimoji="1" lang="ja-JP" altLang="en-US" sz="10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254208721"/>
                  </a:ext>
                </a:extLst>
              </a:tr>
              <a:tr h="217899">
                <a:tc>
                  <a:txBody>
                    <a:bodyPr/>
                    <a:lstStyle/>
                    <a:p>
                      <a:r>
                        <a:rPr kumimoji="1" lang="ja-JP" altLang="en-US" sz="1000" b="1" dirty="0"/>
                        <a:t>％</a:t>
                      </a:r>
                      <a:r>
                        <a:rPr kumimoji="1" lang="en-US" altLang="ja-JP" sz="1000" b="1" dirty="0"/>
                        <a:t>FVC</a:t>
                      </a:r>
                      <a:endParaRPr kumimoji="1" lang="ja-JP" altLang="en-US" sz="10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/>
                        <a:t>79 (69–93)</a:t>
                      </a:r>
                      <a:endParaRPr kumimoji="1" lang="ja-JP" altLang="en-US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/>
                        <a:t>75 (65–88)</a:t>
                      </a:r>
                      <a:endParaRPr kumimoji="1" lang="ja-JP" altLang="en-US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/>
                        <a:t>0.20</a:t>
                      </a:r>
                      <a:endParaRPr kumimoji="1" lang="ja-JP" altLang="en-US" sz="10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673000587"/>
                  </a:ext>
                </a:extLst>
              </a:tr>
              <a:tr h="217899">
                <a:tc>
                  <a:txBody>
                    <a:bodyPr/>
                    <a:lstStyle/>
                    <a:p>
                      <a:r>
                        <a:rPr kumimoji="1" lang="ja-JP" altLang="en-US" sz="1000" b="1" dirty="0"/>
                        <a:t>％</a:t>
                      </a:r>
                      <a:r>
                        <a:rPr kumimoji="1" lang="en-US" altLang="ja-JP" sz="1000" b="1" dirty="0" err="1"/>
                        <a:t>D</a:t>
                      </a:r>
                      <a:r>
                        <a:rPr kumimoji="1" lang="en-US" altLang="ja-JP" sz="1000" b="1" baseline="-25000" dirty="0" err="1"/>
                        <a:t>Lco</a:t>
                      </a:r>
                      <a:endParaRPr kumimoji="1" lang="en-US" altLang="ja-JP" sz="1000" b="1" baseline="-25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/>
                        <a:t>59 (45–71)</a:t>
                      </a:r>
                      <a:endParaRPr kumimoji="1" lang="ja-JP" altLang="en-US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/>
                        <a:t>62 (43–72)</a:t>
                      </a:r>
                      <a:endParaRPr kumimoji="1" lang="ja-JP" altLang="en-US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/>
                        <a:t>0.96</a:t>
                      </a:r>
                      <a:endParaRPr kumimoji="1" lang="ja-JP" altLang="en-US" sz="10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545258406"/>
                  </a:ext>
                </a:extLst>
              </a:tr>
              <a:tr h="217899">
                <a:tc>
                  <a:txBody>
                    <a:bodyPr/>
                    <a:lstStyle/>
                    <a:p>
                      <a:r>
                        <a:rPr kumimoji="1" lang="en-US" altLang="ja-JP" sz="1000" b="1" dirty="0"/>
                        <a:t>HRCT </a:t>
                      </a:r>
                      <a:endParaRPr kumimoji="1" lang="ja-JP" altLang="en-US" sz="10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0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994239213"/>
                  </a:ext>
                </a:extLst>
              </a:tr>
              <a:tr h="217899">
                <a:tc>
                  <a:txBody>
                    <a:bodyPr/>
                    <a:lstStyle/>
                    <a:p>
                      <a:r>
                        <a:rPr kumimoji="1" lang="ja-JP" altLang="en-US" sz="1000" dirty="0"/>
                        <a:t>　</a:t>
                      </a:r>
                      <a:r>
                        <a:rPr kumimoji="1" lang="en-US" altLang="ja-JP" sz="1000" dirty="0"/>
                        <a:t>UIP pattern, N (%)</a:t>
                      </a:r>
                      <a:endParaRPr kumimoji="1" lang="ja-JP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/>
                        <a:t>50 (71)</a:t>
                      </a:r>
                      <a:endParaRPr kumimoji="1" lang="ja-JP" altLang="en-US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/>
                        <a:t>41 (68)</a:t>
                      </a:r>
                      <a:endParaRPr kumimoji="1" lang="ja-JP" altLang="en-US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/>
                        <a:t>0.70</a:t>
                      </a:r>
                      <a:endParaRPr kumimoji="1" lang="ja-JP" altLang="en-US" sz="10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669059383"/>
                  </a:ext>
                </a:extLst>
              </a:tr>
              <a:tr h="217899">
                <a:tc>
                  <a:txBody>
                    <a:bodyPr/>
                    <a:lstStyle/>
                    <a:p>
                      <a:r>
                        <a:rPr kumimoji="1" lang="ja-JP" altLang="en-US" sz="1000" dirty="0"/>
                        <a:t>　</a:t>
                      </a:r>
                      <a:r>
                        <a:rPr kumimoji="1" lang="en-US" altLang="ja-JP" sz="1000" dirty="0"/>
                        <a:t>Probable UIP pattern, N (%)</a:t>
                      </a:r>
                      <a:endParaRPr kumimoji="1" lang="ja-JP" alt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/>
                        <a:t>9 (13)</a:t>
                      </a:r>
                      <a:endParaRPr kumimoji="1" lang="ja-JP" altLang="en-US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/>
                        <a:t>3 (5)</a:t>
                      </a:r>
                      <a:endParaRPr kumimoji="1" lang="ja-JP" altLang="en-US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/>
                        <a:t>0.12</a:t>
                      </a:r>
                      <a:endParaRPr kumimoji="1" lang="ja-JP" altLang="en-US" sz="10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942620122"/>
                  </a:ext>
                </a:extLst>
              </a:tr>
              <a:tr h="217899">
                <a:tc>
                  <a:txBody>
                    <a:bodyPr/>
                    <a:lstStyle/>
                    <a:p>
                      <a:r>
                        <a:rPr kumimoji="1" lang="en-US" altLang="ja-JP" sz="1000" b="1" dirty="0"/>
                        <a:t>GAP score</a:t>
                      </a:r>
                      <a:endParaRPr kumimoji="1" lang="ja-JP" altLang="en-US" sz="10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/>
                        <a:t>3 (3–4)</a:t>
                      </a:r>
                      <a:endParaRPr kumimoji="1" lang="ja-JP" altLang="en-US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/>
                        <a:t>4 (2–4)</a:t>
                      </a:r>
                      <a:endParaRPr kumimoji="1" lang="ja-JP" altLang="en-US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/>
                        <a:t>0.11</a:t>
                      </a:r>
                      <a:endParaRPr kumimoji="1" lang="ja-JP" altLang="en-US" sz="10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200206738"/>
                  </a:ext>
                </a:extLst>
              </a:tr>
              <a:tr h="217899">
                <a:tc>
                  <a:txBody>
                    <a:bodyPr/>
                    <a:lstStyle/>
                    <a:p>
                      <a:r>
                        <a:rPr kumimoji="1" lang="en-US" altLang="ja-JP" sz="1000" b="1" dirty="0"/>
                        <a:t>Anti-fibrotic agent</a:t>
                      </a:r>
                      <a:endParaRPr kumimoji="1" lang="ja-JP" altLang="en-US" sz="10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/>
                        <a:t>0.60</a:t>
                      </a:r>
                      <a:endParaRPr kumimoji="1" lang="ja-JP" altLang="en-US" sz="10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590557422"/>
                  </a:ext>
                </a:extLst>
              </a:tr>
              <a:tr h="217899">
                <a:tc>
                  <a:txBody>
                    <a:bodyPr/>
                    <a:lstStyle/>
                    <a:p>
                      <a:r>
                        <a:rPr kumimoji="1" lang="ja-JP" altLang="en-US" sz="1000" dirty="0"/>
                        <a:t>　</a:t>
                      </a:r>
                      <a:r>
                        <a:rPr kumimoji="1" lang="en-US" altLang="ja-JP" sz="1000" dirty="0"/>
                        <a:t>From diagnosis to starting AFT, days</a:t>
                      </a:r>
                      <a:endParaRPr kumimoji="1" lang="ja-JP" altLang="en-US" sz="1000" dirty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/>
                        <a:t>264 (28-618)</a:t>
                      </a:r>
                      <a:endParaRPr kumimoji="1" lang="ja-JP" altLang="en-US" sz="1000" dirty="0"/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/>
                        <a:t>236 (108-753)</a:t>
                      </a:r>
                      <a:endParaRPr kumimoji="1" lang="ja-JP" altLang="en-US" sz="1000" dirty="0"/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/>
                        <a:t>0.43</a:t>
                      </a:r>
                      <a:endParaRPr kumimoji="1" lang="ja-JP" altLang="en-US" sz="1000" dirty="0"/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58488450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DA3FD359-D048-C3A4-351F-39DEFDA7C99D}"/>
              </a:ext>
            </a:extLst>
          </p:cNvPr>
          <p:cNvSpPr txBox="1"/>
          <p:nvPr/>
        </p:nvSpPr>
        <p:spPr>
          <a:xfrm>
            <a:off x="591687" y="0"/>
            <a:ext cx="79606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b="1" dirty="0">
                <a:latin typeface="Calibri"/>
                <a:ea typeface="游ゴシック" panose="020B0400000000000000" pitchFamily="50" charset="-128"/>
                <a:cs typeface="Arial" panose="020B0604020202020204" pitchFamily="34" charset="0"/>
              </a:rPr>
              <a:t>Supplement Table</a:t>
            </a: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/>
                <a:ea typeface="游ゴシック" panose="020B0400000000000000" pitchFamily="50" charset="-128"/>
                <a:cs typeface="Arial" panose="020B0604020202020204" pitchFamily="34" charset="0"/>
              </a:rPr>
              <a:t> 1. Patients’ baseline data for </a:t>
            </a:r>
            <a:r>
              <a:rPr kumimoji="1" lang="en-US" altLang="ja-JP" sz="1800" b="1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Calibri"/>
                <a:ea typeface="游ゴシック" panose="020B0400000000000000" pitchFamily="50" charset="-128"/>
                <a:cs typeface="Arial" panose="020B0604020202020204" pitchFamily="34" charset="0"/>
              </a:rPr>
              <a:t>nintedanib</a:t>
            </a: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/>
                <a:ea typeface="游ゴシック" panose="020B0400000000000000" pitchFamily="50" charset="-128"/>
                <a:cs typeface="Arial" panose="020B0604020202020204" pitchFamily="34" charset="0"/>
              </a:rPr>
              <a:t> or pirfenidone groups</a:t>
            </a:r>
          </a:p>
        </p:txBody>
      </p:sp>
    </p:spTree>
    <p:extLst>
      <p:ext uri="{BB962C8B-B14F-4D97-AF65-F5344CB8AC3E}">
        <p14:creationId xmlns:p14="http://schemas.microsoft.com/office/powerpoint/2010/main" val="34055131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96</TotalTime>
  <Words>253</Words>
  <Application>Microsoft Office PowerPoint</Application>
  <PresentationFormat>画面に合わせる (4:3)</PresentationFormat>
  <Paragraphs>52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原　悠</dc:creator>
  <cp:lastModifiedBy>原　悠</cp:lastModifiedBy>
  <cp:revision>9</cp:revision>
  <cp:lastPrinted>2023-03-25T22:56:31Z</cp:lastPrinted>
  <dcterms:created xsi:type="dcterms:W3CDTF">2022-10-17T23:58:32Z</dcterms:created>
  <dcterms:modified xsi:type="dcterms:W3CDTF">2023-08-06T06:10:13Z</dcterms:modified>
</cp:coreProperties>
</file>